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16" r:id="rId2"/>
    <p:sldId id="314" r:id="rId3"/>
    <p:sldId id="315" r:id="rId4"/>
    <p:sldId id="31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C901A2D-040D-47CE-837C-6BCC43A40904}" v="4" dt="2024-03-06T14:05:31.5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3792" autoAdjust="0"/>
  </p:normalViewPr>
  <p:slideViewPr>
    <p:cSldViewPr snapToGrid="0">
      <p:cViewPr varScale="1">
        <p:scale>
          <a:sx n="75" d="100"/>
          <a:sy n="75" d="100"/>
        </p:scale>
        <p:origin x="321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ng, Meihong" userId="872a43b5-c79e-4b1c-b889-eaa83c4d2efd" providerId="ADAL" clId="{CC901A2D-040D-47CE-837C-6BCC43A40904}"/>
    <pc:docChg chg="addSld delSld modSld">
      <pc:chgData name="Deng, Meihong" userId="872a43b5-c79e-4b1c-b889-eaa83c4d2efd" providerId="ADAL" clId="{CC901A2D-040D-47CE-837C-6BCC43A40904}" dt="2024-03-06T14:05:33.395" v="11" actId="47"/>
      <pc:docMkLst>
        <pc:docMk/>
      </pc:docMkLst>
      <pc:sldChg chg="del">
        <pc:chgData name="Deng, Meihong" userId="872a43b5-c79e-4b1c-b889-eaa83c4d2efd" providerId="ADAL" clId="{CC901A2D-040D-47CE-837C-6BCC43A40904}" dt="2024-03-06T14:04:09.100" v="3" actId="47"/>
        <pc:sldMkLst>
          <pc:docMk/>
          <pc:sldMk cId="4059983361" sldId="256"/>
        </pc:sldMkLst>
      </pc:sldChg>
      <pc:sldChg chg="del">
        <pc:chgData name="Deng, Meihong" userId="872a43b5-c79e-4b1c-b889-eaa83c4d2efd" providerId="ADAL" clId="{CC901A2D-040D-47CE-837C-6BCC43A40904}" dt="2024-03-06T14:04:38.002" v="5" actId="47"/>
        <pc:sldMkLst>
          <pc:docMk/>
          <pc:sldMk cId="4098662911" sldId="258"/>
        </pc:sldMkLst>
      </pc:sldChg>
      <pc:sldChg chg="del">
        <pc:chgData name="Deng, Meihong" userId="872a43b5-c79e-4b1c-b889-eaa83c4d2efd" providerId="ADAL" clId="{CC901A2D-040D-47CE-837C-6BCC43A40904}" dt="2024-03-06T14:05:10.433" v="9" actId="47"/>
        <pc:sldMkLst>
          <pc:docMk/>
          <pc:sldMk cId="3074449370" sldId="259"/>
        </pc:sldMkLst>
      </pc:sldChg>
      <pc:sldChg chg="del">
        <pc:chgData name="Deng, Meihong" userId="872a43b5-c79e-4b1c-b889-eaa83c4d2efd" providerId="ADAL" clId="{CC901A2D-040D-47CE-837C-6BCC43A40904}" dt="2024-03-06T14:05:33.395" v="11" actId="47"/>
        <pc:sldMkLst>
          <pc:docMk/>
          <pc:sldMk cId="4124061388" sldId="261"/>
        </pc:sldMkLst>
      </pc:sldChg>
      <pc:sldChg chg="del">
        <pc:chgData name="Deng, Meihong" userId="872a43b5-c79e-4b1c-b889-eaa83c4d2efd" providerId="ADAL" clId="{CC901A2D-040D-47CE-837C-6BCC43A40904}" dt="2024-03-06T14:05:08.175" v="8" actId="47"/>
        <pc:sldMkLst>
          <pc:docMk/>
          <pc:sldMk cId="1344391562" sldId="313"/>
        </pc:sldMkLst>
      </pc:sldChg>
      <pc:sldChg chg="add del">
        <pc:chgData name="Deng, Meihong" userId="872a43b5-c79e-4b1c-b889-eaa83c4d2efd" providerId="ADAL" clId="{CC901A2D-040D-47CE-837C-6BCC43A40904}" dt="2024-03-06T14:04:12.091" v="4"/>
        <pc:sldMkLst>
          <pc:docMk/>
          <pc:sldMk cId="689167663" sldId="314"/>
        </pc:sldMkLst>
      </pc:sldChg>
      <pc:sldChg chg="add del">
        <pc:chgData name="Deng, Meihong" userId="872a43b5-c79e-4b1c-b889-eaa83c4d2efd" providerId="ADAL" clId="{CC901A2D-040D-47CE-837C-6BCC43A40904}" dt="2024-03-06T14:05:04.807" v="7"/>
        <pc:sldMkLst>
          <pc:docMk/>
          <pc:sldMk cId="270694624" sldId="315"/>
        </pc:sldMkLst>
      </pc:sldChg>
      <pc:sldChg chg="add del">
        <pc:chgData name="Deng, Meihong" userId="872a43b5-c79e-4b1c-b889-eaa83c4d2efd" providerId="ADAL" clId="{CC901A2D-040D-47CE-837C-6BCC43A40904}" dt="2024-03-06T14:03:53.657" v="1"/>
        <pc:sldMkLst>
          <pc:docMk/>
          <pc:sldMk cId="2946074761" sldId="316"/>
        </pc:sldMkLst>
      </pc:sldChg>
      <pc:sldChg chg="del">
        <pc:chgData name="Deng, Meihong" userId="872a43b5-c79e-4b1c-b889-eaa83c4d2efd" providerId="ADAL" clId="{CC901A2D-040D-47CE-837C-6BCC43A40904}" dt="2024-03-06T14:05:14.428" v="10" actId="47"/>
        <pc:sldMkLst>
          <pc:docMk/>
          <pc:sldMk cId="2585928819" sldId="31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9EAC1A-2399-4BF3-AB9E-E689DCF7D11B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F61647-C4B0-4DF0-8B24-1668095BC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863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025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29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355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905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753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94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54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672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34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932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271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A5F61-4B1A-46B7-A333-4580E3301C43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BB59C-B415-4D2A-B7C4-A41254140F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879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1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tif"/><Relationship Id="rId4" Type="http://schemas.openxmlformats.org/officeDocument/2006/relationships/image" Target="../media/image1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>
            <a:extLst>
              <a:ext uri="{FF2B5EF4-FFF2-40B4-BE49-F238E27FC236}">
                <a16:creationId xmlns:a16="http://schemas.microsoft.com/office/drawing/2014/main" id="{A4D4704D-54A7-73BA-72B1-28DD447D80D7}"/>
              </a:ext>
            </a:extLst>
          </p:cNvPr>
          <p:cNvGrpSpPr/>
          <p:nvPr/>
        </p:nvGrpSpPr>
        <p:grpSpPr>
          <a:xfrm>
            <a:off x="638611" y="560911"/>
            <a:ext cx="6173312" cy="5873039"/>
            <a:chOff x="638611" y="560911"/>
            <a:chExt cx="6173312" cy="5873039"/>
          </a:xfrm>
        </p:grpSpPr>
        <p:pic>
          <p:nvPicPr>
            <p:cNvPr id="5" name="Picture 4" descr="A graph of a person's body&#10;&#10;Description automatically generated with medium confidence">
              <a:extLst>
                <a:ext uri="{FF2B5EF4-FFF2-40B4-BE49-F238E27FC236}">
                  <a16:creationId xmlns:a16="http://schemas.microsoft.com/office/drawing/2014/main" id="{30C5E73B-FEC6-FCA3-9554-CB40F97E61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9120" y="4600927"/>
              <a:ext cx="1725111" cy="1727435"/>
            </a:xfrm>
            <a:prstGeom prst="rect">
              <a:avLst/>
            </a:prstGeom>
          </p:spPr>
        </p:pic>
        <p:pic>
          <p:nvPicPr>
            <p:cNvPr id="7" name="Picture 6" descr="A graph of a cloud&#10;&#10;Description automatically generated">
              <a:extLst>
                <a:ext uri="{FF2B5EF4-FFF2-40B4-BE49-F238E27FC236}">
                  <a16:creationId xmlns:a16="http://schemas.microsoft.com/office/drawing/2014/main" id="{E0D8AD77-24CF-E1B2-F0A7-A73D1275FC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365" y="4607690"/>
              <a:ext cx="1716124" cy="1688973"/>
            </a:xfrm>
            <a:prstGeom prst="rect">
              <a:avLst/>
            </a:prstGeom>
          </p:spPr>
        </p:pic>
        <p:pic>
          <p:nvPicPr>
            <p:cNvPr id="9" name="Picture 8" descr="A graph of a graph of a hexagon&#10;&#10;Description automatically generated with medium confidence">
              <a:extLst>
                <a:ext uri="{FF2B5EF4-FFF2-40B4-BE49-F238E27FC236}">
                  <a16:creationId xmlns:a16="http://schemas.microsoft.com/office/drawing/2014/main" id="{E7397D08-0B51-A48C-1874-109E40CED2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480" y="652526"/>
              <a:ext cx="1845838" cy="1888236"/>
            </a:xfrm>
            <a:prstGeom prst="rect">
              <a:avLst/>
            </a:prstGeom>
          </p:spPr>
        </p:pic>
        <p:pic>
          <p:nvPicPr>
            <p:cNvPr id="11" name="Picture 10" descr="A diagram of a red and blue line&#10;&#10;Description automatically generated">
              <a:extLst>
                <a:ext uri="{FF2B5EF4-FFF2-40B4-BE49-F238E27FC236}">
                  <a16:creationId xmlns:a16="http://schemas.microsoft.com/office/drawing/2014/main" id="{D956B17E-EB0F-E424-D4D7-994B328091C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75814" y="684022"/>
              <a:ext cx="1883664" cy="1888236"/>
            </a:xfrm>
            <a:prstGeom prst="rect">
              <a:avLst/>
            </a:prstGeom>
          </p:spPr>
        </p:pic>
        <p:pic>
          <p:nvPicPr>
            <p:cNvPr id="13" name="Picture 12" descr="A graph with a number of colored dots&#10;&#10;Description automatically generated with medium confidence">
              <a:extLst>
                <a:ext uri="{FF2B5EF4-FFF2-40B4-BE49-F238E27FC236}">
                  <a16:creationId xmlns:a16="http://schemas.microsoft.com/office/drawing/2014/main" id="{404EB11E-719D-B0A1-C03A-76643B7811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9478" y="684022"/>
              <a:ext cx="1895856" cy="1912620"/>
            </a:xfrm>
            <a:prstGeom prst="rect">
              <a:avLst/>
            </a:prstGeom>
          </p:spPr>
        </p:pic>
        <p:pic>
          <p:nvPicPr>
            <p:cNvPr id="15" name="Picture 14" descr="A diagram of a blue and red dotted chart&#10;&#10;Description automatically generated with medium confidence">
              <a:extLst>
                <a:ext uri="{FF2B5EF4-FFF2-40B4-BE49-F238E27FC236}">
                  <a16:creationId xmlns:a16="http://schemas.microsoft.com/office/drawing/2014/main" id="{61075ED5-DD3E-83D6-C3F8-1E8EAAD2D75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7794" y="2562352"/>
              <a:ext cx="1883664" cy="1854496"/>
            </a:xfrm>
            <a:prstGeom prst="rect">
              <a:avLst/>
            </a:prstGeom>
          </p:spPr>
        </p:pic>
        <p:pic>
          <p:nvPicPr>
            <p:cNvPr id="17" name="Picture 16" descr="A graph of a sample&#10;&#10;Description automatically generated with medium confidence">
              <a:extLst>
                <a:ext uri="{FF2B5EF4-FFF2-40B4-BE49-F238E27FC236}">
                  <a16:creationId xmlns:a16="http://schemas.microsoft.com/office/drawing/2014/main" id="{B8472C03-ACDA-57D6-D263-D1009CEED5F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39238" y="2576576"/>
              <a:ext cx="1920240" cy="1853184"/>
            </a:xfrm>
            <a:prstGeom prst="rect">
              <a:avLst/>
            </a:prstGeom>
          </p:spPr>
        </p:pic>
        <p:pic>
          <p:nvPicPr>
            <p:cNvPr id="19" name="Picture 18" descr="A diagram of a graph&#10;&#10;Description automatically generated with medium confidence">
              <a:extLst>
                <a:ext uri="{FF2B5EF4-FFF2-40B4-BE49-F238E27FC236}">
                  <a16:creationId xmlns:a16="http://schemas.microsoft.com/office/drawing/2014/main" id="{7EA5ADD9-0AF3-D9FB-4015-E8A0298605C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3180" y="2561082"/>
              <a:ext cx="1895856" cy="1889760"/>
            </a:xfrm>
            <a:prstGeom prst="rect">
              <a:avLst/>
            </a:prstGeom>
          </p:spPr>
        </p:pic>
        <p:pic>
          <p:nvPicPr>
            <p:cNvPr id="21" name="Picture 20" descr="A graph of a number of samples&#10;&#10;Description automatically generated with medium confidence">
              <a:extLst>
                <a:ext uri="{FF2B5EF4-FFF2-40B4-BE49-F238E27FC236}">
                  <a16:creationId xmlns:a16="http://schemas.microsoft.com/office/drawing/2014/main" id="{AA221582-C597-207B-EAC7-0018E9C5D2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879" y="4544190"/>
              <a:ext cx="1906524" cy="1889760"/>
            </a:xfrm>
            <a:prstGeom prst="rect">
              <a:avLst/>
            </a:prstGeom>
          </p:spPr>
        </p:pic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B7AB7248-54F2-4C0D-404E-5980D88A18AC}"/>
                </a:ext>
              </a:extLst>
            </p:cNvPr>
            <p:cNvCxnSpPr/>
            <p:nvPr/>
          </p:nvCxnSpPr>
          <p:spPr>
            <a:xfrm>
              <a:off x="2273300" y="1856358"/>
              <a:ext cx="9779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1482EFDB-C143-1482-4B57-A5AFF43280E3}"/>
                </a:ext>
              </a:extLst>
            </p:cNvPr>
            <p:cNvCxnSpPr/>
            <p:nvPr/>
          </p:nvCxnSpPr>
          <p:spPr>
            <a:xfrm>
              <a:off x="4193955" y="1845816"/>
              <a:ext cx="9779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034988F1-B8C0-43BF-6BA5-F1DFAC315430}"/>
                </a:ext>
              </a:extLst>
            </p:cNvPr>
            <p:cNvCxnSpPr>
              <a:cxnSpLocks/>
            </p:cNvCxnSpPr>
            <p:nvPr/>
          </p:nvCxnSpPr>
          <p:spPr>
            <a:xfrm>
              <a:off x="5260755" y="2275966"/>
              <a:ext cx="0" cy="59258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5980C71C-A4AD-C2A7-3F9A-A530341187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43936" y="3862958"/>
              <a:ext cx="106596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82A8B320-943D-7267-EDBF-450792F496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85231" y="3862958"/>
              <a:ext cx="88560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4583195F-AFFE-44AD-FC98-CDC54FB689BF}"/>
                </a:ext>
              </a:extLst>
            </p:cNvPr>
            <p:cNvCxnSpPr>
              <a:cxnSpLocks/>
            </p:cNvCxnSpPr>
            <p:nvPr/>
          </p:nvCxnSpPr>
          <p:spPr>
            <a:xfrm>
              <a:off x="1771279" y="3992370"/>
              <a:ext cx="0" cy="7709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25A8E56-DDCD-BE3F-388F-795371A7C85B}"/>
                </a:ext>
              </a:extLst>
            </p:cNvPr>
            <p:cNvSpPr txBox="1"/>
            <p:nvPr/>
          </p:nvSpPr>
          <p:spPr>
            <a:xfrm>
              <a:off x="5699149" y="4228751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F8C29DB-D50E-4955-7CCB-4C522648F15B}"/>
                </a:ext>
              </a:extLst>
            </p:cNvPr>
            <p:cNvSpPr txBox="1"/>
            <p:nvPr/>
          </p:nvSpPr>
          <p:spPr>
            <a:xfrm>
              <a:off x="3840555" y="4229386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C05B04F-2CF5-D506-0E2B-0F34173F3D16}"/>
                </a:ext>
              </a:extLst>
            </p:cNvPr>
            <p:cNvSpPr txBox="1"/>
            <p:nvPr/>
          </p:nvSpPr>
          <p:spPr>
            <a:xfrm>
              <a:off x="2076079" y="4228751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DP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E55613F-72D3-1C91-BD9A-88E036066B1D}"/>
                </a:ext>
              </a:extLst>
            </p:cNvPr>
            <p:cNvSpPr txBox="1"/>
            <p:nvPr/>
          </p:nvSpPr>
          <p:spPr>
            <a:xfrm rot="16200000">
              <a:off x="222316" y="5365959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5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E1D0022-6A6E-A81E-09C8-70C069602087}"/>
                </a:ext>
              </a:extLst>
            </p:cNvPr>
            <p:cNvSpPr txBox="1"/>
            <p:nvPr/>
          </p:nvSpPr>
          <p:spPr>
            <a:xfrm rot="16200000">
              <a:off x="2183103" y="4995579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D5F6DF9-4AEC-7204-FB79-DB4A58BA19A2}"/>
                </a:ext>
              </a:extLst>
            </p:cNvPr>
            <p:cNvSpPr txBox="1"/>
            <p:nvPr/>
          </p:nvSpPr>
          <p:spPr>
            <a:xfrm rot="16200000">
              <a:off x="4014518" y="4926536"/>
              <a:ext cx="11127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4C8AD31-D226-5AFF-9C90-AD713EB9C91F}"/>
                </a:ext>
              </a:extLst>
            </p:cNvPr>
            <p:cNvSpPr txBox="1"/>
            <p:nvPr/>
          </p:nvSpPr>
          <p:spPr>
            <a:xfrm>
              <a:off x="638611" y="560911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B5E6B86-8725-3F71-6993-461B40534178}"/>
                </a:ext>
              </a:extLst>
            </p:cNvPr>
            <p:cNvSpPr txBox="1"/>
            <p:nvPr/>
          </p:nvSpPr>
          <p:spPr>
            <a:xfrm>
              <a:off x="2540321" y="586232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395AAC6-FA58-A9C6-E2BD-1B115547068E}"/>
                </a:ext>
              </a:extLst>
            </p:cNvPr>
            <p:cNvSpPr txBox="1"/>
            <p:nvPr/>
          </p:nvSpPr>
          <p:spPr>
            <a:xfrm>
              <a:off x="4432621" y="586232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A456C4F-A68B-496E-FC19-C1D14F18A551}"/>
                </a:ext>
              </a:extLst>
            </p:cNvPr>
            <p:cNvSpPr txBox="1"/>
            <p:nvPr/>
          </p:nvSpPr>
          <p:spPr>
            <a:xfrm>
              <a:off x="4421652" y="2465197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81C8782-283F-897C-2AA6-8E89CED19325}"/>
                </a:ext>
              </a:extLst>
            </p:cNvPr>
            <p:cNvSpPr txBox="1"/>
            <p:nvPr/>
          </p:nvSpPr>
          <p:spPr>
            <a:xfrm>
              <a:off x="2589550" y="2508932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8606BA3-3C72-91A0-3D2C-7C187AF6C809}"/>
                </a:ext>
              </a:extLst>
            </p:cNvPr>
            <p:cNvSpPr txBox="1"/>
            <p:nvPr/>
          </p:nvSpPr>
          <p:spPr>
            <a:xfrm>
              <a:off x="707136" y="2483945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6535B9C-EE60-CC5E-7771-C5E26C5462F5}"/>
                </a:ext>
              </a:extLst>
            </p:cNvPr>
            <p:cNvSpPr txBox="1"/>
            <p:nvPr/>
          </p:nvSpPr>
          <p:spPr>
            <a:xfrm>
              <a:off x="767786" y="4453592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3DCD1C6-E576-9318-ABC1-0D2B0113AE27}"/>
                </a:ext>
              </a:extLst>
            </p:cNvPr>
            <p:cNvSpPr txBox="1"/>
            <p:nvPr/>
          </p:nvSpPr>
          <p:spPr>
            <a:xfrm>
              <a:off x="2635689" y="4517091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C4B6BA6-CD18-C211-7896-7DFD7B981F4A}"/>
                </a:ext>
              </a:extLst>
            </p:cNvPr>
            <p:cNvSpPr txBox="1"/>
            <p:nvPr/>
          </p:nvSpPr>
          <p:spPr>
            <a:xfrm>
              <a:off x="4553596" y="4482554"/>
              <a:ext cx="546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A2B8759-B55E-A6E8-063F-244AE2584F48}"/>
              </a:ext>
            </a:extLst>
          </p:cNvPr>
          <p:cNvSpPr txBox="1"/>
          <p:nvPr/>
        </p:nvSpPr>
        <p:spPr>
          <a:xfrm>
            <a:off x="803432" y="6636655"/>
            <a:ext cx="56608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A-G: Representative gating strategies of cell sorting for t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 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 CD3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 PDPN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 CD3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 PDPN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uman FRC using BD Aria Plus high-speed sorter. H &amp; I: Expression of CD55 was assessed in the sorted 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i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H) and CD5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I) FRC after 7 days ex vivo expans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6074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60">
            <a:extLst>
              <a:ext uri="{FF2B5EF4-FFF2-40B4-BE49-F238E27FC236}">
                <a16:creationId xmlns:a16="http://schemas.microsoft.com/office/drawing/2014/main" id="{5ACE37CE-6E63-5117-FAEA-38766DCD0278}"/>
              </a:ext>
            </a:extLst>
          </p:cNvPr>
          <p:cNvGrpSpPr/>
          <p:nvPr/>
        </p:nvGrpSpPr>
        <p:grpSpPr>
          <a:xfrm>
            <a:off x="992143" y="834109"/>
            <a:ext cx="5450630" cy="1631008"/>
            <a:chOff x="992143" y="834109"/>
            <a:chExt cx="5450630" cy="1631008"/>
          </a:xfrm>
        </p:grpSpPr>
        <p:graphicFrame>
          <p:nvGraphicFramePr>
            <p:cNvPr id="51" name="Object 50">
              <a:extLst>
                <a:ext uri="{FF2B5EF4-FFF2-40B4-BE49-F238E27FC236}">
                  <a16:creationId xmlns:a16="http://schemas.microsoft.com/office/drawing/2014/main" id="{B515E26B-A556-5B1F-5BFF-2CEDE5422E3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136074" y="857951"/>
            <a:ext cx="1756579" cy="16011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707500" imgH="2469203" progId="Prism10.Document">
                    <p:embed/>
                  </p:oleObj>
                </mc:Choice>
                <mc:Fallback>
                  <p:oleObj name="Prism 10" r:id="rId2" imgW="2707500" imgH="2469203" progId="Prism10.Document">
                    <p:embed/>
                    <p:pic>
                      <p:nvPicPr>
                        <p:cNvPr id="51" name="Object 50">
                          <a:extLst>
                            <a:ext uri="{FF2B5EF4-FFF2-40B4-BE49-F238E27FC236}">
                              <a16:creationId xmlns:a16="http://schemas.microsoft.com/office/drawing/2014/main" id="{B515E26B-A556-5B1F-5BFF-2CEDE5422E3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136074" y="857951"/>
                          <a:ext cx="1756579" cy="160110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81EEC7D-0AB0-9E4C-4521-F1C57E165817}"/>
                </a:ext>
              </a:extLst>
            </p:cNvPr>
            <p:cNvSpPr txBox="1"/>
            <p:nvPr/>
          </p:nvSpPr>
          <p:spPr>
            <a:xfrm>
              <a:off x="4107464" y="1107626"/>
              <a:ext cx="83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Ccl19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Cre</a:t>
              </a:r>
              <a:endParaRPr lang="en-US" sz="8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BF2A205-D18E-9D84-F616-1587F9F4A3BA}"/>
                </a:ext>
              </a:extLst>
            </p:cNvPr>
            <p:cNvSpPr txBox="1"/>
            <p:nvPr/>
          </p:nvSpPr>
          <p:spPr>
            <a:xfrm>
              <a:off x="4107465" y="999904"/>
              <a:ext cx="7206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Tlr9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fl/</a:t>
              </a:r>
              <a:r>
                <a:rPr lang="en-US" sz="800" i="1" baseline="300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fl</a:t>
              </a:r>
              <a:endParaRPr lang="en-US" sz="8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72B9B57-D9A1-0E7A-18B9-7C770AEE5418}"/>
                </a:ext>
              </a:extLst>
            </p:cNvPr>
            <p:cNvSpPr txBox="1"/>
            <p:nvPr/>
          </p:nvSpPr>
          <p:spPr>
            <a:xfrm>
              <a:off x="3309644" y="2210115"/>
              <a:ext cx="7206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PLF</a:t>
              </a:r>
              <a:endParaRPr lang="en-US" sz="8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646408C-9E69-91BB-EB08-CF8B1332F227}"/>
                </a:ext>
              </a:extLst>
            </p:cNvPr>
            <p:cNvSpPr txBox="1"/>
            <p:nvPr/>
          </p:nvSpPr>
          <p:spPr>
            <a:xfrm>
              <a:off x="3918900" y="2197991"/>
              <a:ext cx="7206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Blood</a:t>
              </a:r>
              <a:endParaRPr lang="en-US" sz="8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C8D838A-238F-F82B-2D42-20A06FFEBC9B}"/>
                </a:ext>
              </a:extLst>
            </p:cNvPr>
            <p:cNvSpPr txBox="1"/>
            <p:nvPr/>
          </p:nvSpPr>
          <p:spPr>
            <a:xfrm>
              <a:off x="3082543" y="2127660"/>
              <a:ext cx="394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10</a:t>
              </a:r>
              <a:r>
                <a:rPr lang="en-US" sz="8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2</a:t>
              </a:r>
              <a:endParaRPr lang="en-US" sz="8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CBA5D6-C399-ADF8-47A8-568AC7726CC1}"/>
                </a:ext>
              </a:extLst>
            </p:cNvPr>
            <p:cNvSpPr txBox="1"/>
            <p:nvPr/>
          </p:nvSpPr>
          <p:spPr>
            <a:xfrm>
              <a:off x="3082896" y="1735910"/>
              <a:ext cx="3942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10</a:t>
              </a:r>
              <a:r>
                <a:rPr lang="en-US" sz="8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4</a:t>
              </a:r>
              <a:endParaRPr lang="en-US" sz="8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C9410D1-CE17-4820-8E9E-CFFFD57A0542}"/>
                </a:ext>
              </a:extLst>
            </p:cNvPr>
            <p:cNvSpPr txBox="1"/>
            <p:nvPr/>
          </p:nvSpPr>
          <p:spPr>
            <a:xfrm>
              <a:off x="3085036" y="1333322"/>
              <a:ext cx="3942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10</a:t>
              </a:r>
              <a:r>
                <a:rPr lang="en-US" sz="8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6</a:t>
              </a:r>
              <a:endParaRPr lang="en-US" sz="8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A95354F-7150-78E2-A247-86E6858F015B}"/>
                </a:ext>
              </a:extLst>
            </p:cNvPr>
            <p:cNvSpPr txBox="1"/>
            <p:nvPr/>
          </p:nvSpPr>
          <p:spPr>
            <a:xfrm>
              <a:off x="3080854" y="917203"/>
              <a:ext cx="3942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10</a:t>
              </a:r>
              <a:r>
                <a:rPr lang="en-US" sz="8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</a:rPr>
                <a:t>8</a:t>
              </a:r>
              <a:endParaRPr 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D8269DE-A56B-F3A2-718B-A7190612CEA2}"/>
                </a:ext>
              </a:extLst>
            </p:cNvPr>
            <p:cNvSpPr txBox="1"/>
            <p:nvPr/>
          </p:nvSpPr>
          <p:spPr>
            <a:xfrm>
              <a:off x="3536713" y="868154"/>
              <a:ext cx="990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acterial load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504ABFB-E4F9-D6F1-D0F1-02F92B4AAB74}"/>
                </a:ext>
              </a:extLst>
            </p:cNvPr>
            <p:cNvSpPr txBox="1"/>
            <p:nvPr/>
          </p:nvSpPr>
          <p:spPr>
            <a:xfrm rot="16200000">
              <a:off x="2636437" y="1235527"/>
              <a:ext cx="1025672" cy="2228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FU/m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1E0C2DB-036D-248E-3594-737CAF0298EB}"/>
                </a:ext>
              </a:extLst>
            </p:cNvPr>
            <p:cNvSpPr txBox="1"/>
            <p:nvPr/>
          </p:nvSpPr>
          <p:spPr>
            <a:xfrm>
              <a:off x="3015589" y="849999"/>
              <a:ext cx="3267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5A397615-AF0F-C382-CEFF-7CF61F0BAFB3}"/>
                </a:ext>
              </a:extLst>
            </p:cNvPr>
            <p:cNvGrpSpPr/>
            <p:nvPr/>
          </p:nvGrpSpPr>
          <p:grpSpPr>
            <a:xfrm>
              <a:off x="4556564" y="865796"/>
              <a:ext cx="1886209" cy="1599321"/>
              <a:chOff x="2150942" y="655206"/>
              <a:chExt cx="1886209" cy="1599321"/>
            </a:xfrm>
          </p:grpSpPr>
          <p:graphicFrame>
            <p:nvGraphicFramePr>
              <p:cNvPr id="24" name="Object 23">
                <a:extLst>
                  <a:ext uri="{FF2B5EF4-FFF2-40B4-BE49-F238E27FC236}">
                    <a16:creationId xmlns:a16="http://schemas.microsoft.com/office/drawing/2014/main" id="{E5006C38-6DE4-FE8F-D2C7-9ACDC5136CD8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150942" y="655206"/>
              <a:ext cx="1806050" cy="159932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4" imgW="2787090" imgH="2469203" progId="Prism10.Document">
                      <p:embed/>
                    </p:oleObj>
                  </mc:Choice>
                  <mc:Fallback>
                    <p:oleObj name="Prism 10" r:id="rId4" imgW="2787090" imgH="2469203" progId="Prism10.Document">
                      <p:embed/>
                      <p:pic>
                        <p:nvPicPr>
                          <p:cNvPr id="24" name="Object 23">
                            <a:extLst>
                              <a:ext uri="{FF2B5EF4-FFF2-40B4-BE49-F238E27FC236}">
                                <a16:creationId xmlns:a16="http://schemas.microsoft.com/office/drawing/2014/main" id="{E5006C38-6DE4-FE8F-D2C7-9ACDC5136CD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150942" y="655206"/>
                            <a:ext cx="1806050" cy="159932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8FB85C2-7A0F-EF10-45FC-A84BA32F166B}"/>
                  </a:ext>
                </a:extLst>
              </p:cNvPr>
              <p:cNvSpPr txBox="1"/>
              <p:nvPr/>
            </p:nvSpPr>
            <p:spPr>
              <a:xfrm>
                <a:off x="3176903" y="953735"/>
                <a:ext cx="860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Ccl19</a:t>
                </a:r>
                <a:r>
                  <a:rPr lang="en-US" sz="800" i="1" baseline="300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Cre</a:t>
                </a:r>
                <a:endParaRPr lang="en-US" sz="8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F0BBA0E-061B-74D8-D97E-28BFDFA8C3CC}"/>
                  </a:ext>
                </a:extLst>
              </p:cNvPr>
              <p:cNvSpPr txBox="1"/>
              <p:nvPr/>
            </p:nvSpPr>
            <p:spPr>
              <a:xfrm>
                <a:off x="3176902" y="846013"/>
                <a:ext cx="7465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Tlr9</a:t>
                </a:r>
                <a:r>
                  <a:rPr lang="en-US" sz="800" i="1" baseline="300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fl/</a:t>
                </a:r>
                <a:r>
                  <a:rPr lang="en-US" sz="800" i="1" baseline="30000" dirty="0" err="1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fl</a:t>
                </a:r>
                <a:endParaRPr lang="en-US" sz="8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972DAA8-4F5E-0FAF-A68B-6D5685FDD768}"/>
                  </a:ext>
                </a:extLst>
              </p:cNvPr>
              <p:cNvSpPr txBox="1"/>
              <p:nvPr/>
            </p:nvSpPr>
            <p:spPr>
              <a:xfrm>
                <a:off x="2368929" y="1997317"/>
                <a:ext cx="7465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PLF</a:t>
                </a:r>
                <a:endParaRPr lang="en-US" sz="8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FF2754E-232F-AC06-80B6-C30FA3C73198}"/>
                  </a:ext>
                </a:extLst>
              </p:cNvPr>
              <p:cNvSpPr txBox="1"/>
              <p:nvPr/>
            </p:nvSpPr>
            <p:spPr>
              <a:xfrm>
                <a:off x="3023905" y="2005067"/>
                <a:ext cx="7465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Blood</a:t>
                </a:r>
                <a:endParaRPr lang="en-US" sz="800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8F23C68-E01F-4685-9349-145F21E96287}"/>
                  </a:ext>
                </a:extLst>
              </p:cNvPr>
              <p:cNvSpPr txBox="1"/>
              <p:nvPr/>
            </p:nvSpPr>
            <p:spPr>
              <a:xfrm>
                <a:off x="2181712" y="1882089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0</a:t>
                </a:r>
                <a:endParaRPr lang="en-US" sz="8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831E67D-2CF5-DB98-8454-0D64E70CE6E5}"/>
                  </a:ext>
                </a:extLst>
              </p:cNvPr>
              <p:cNvSpPr txBox="1"/>
              <p:nvPr/>
            </p:nvSpPr>
            <p:spPr>
              <a:xfrm>
                <a:off x="2217139" y="1506488"/>
                <a:ext cx="3491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2</a:t>
                </a:r>
                <a:endParaRPr lang="en-US" sz="8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BA65D6B-8225-DB34-FED1-F53B8C73BFF4}"/>
                  </a:ext>
                </a:extLst>
              </p:cNvPr>
              <p:cNvSpPr txBox="1"/>
              <p:nvPr/>
            </p:nvSpPr>
            <p:spPr>
              <a:xfrm>
                <a:off x="2209400" y="1092957"/>
                <a:ext cx="341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4</a:t>
                </a:r>
                <a:endParaRPr lang="en-US" sz="800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519CB4A-2916-1630-A15F-D1152C502819}"/>
                  </a:ext>
                </a:extLst>
              </p:cNvPr>
              <p:cNvSpPr txBox="1"/>
              <p:nvPr/>
            </p:nvSpPr>
            <p:spPr>
              <a:xfrm>
                <a:off x="2214968" y="696160"/>
                <a:ext cx="341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20277AED-639C-E7B8-AE71-DEB5DD4E9EAB}"/>
                  </a:ext>
                </a:extLst>
              </p:cNvPr>
              <p:cNvSpPr txBox="1"/>
              <p:nvPr/>
            </p:nvSpPr>
            <p:spPr>
              <a:xfrm>
                <a:off x="2782698" y="677323"/>
                <a:ext cx="4241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L-6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AACB9C0-EF6E-14E3-9B81-C76C1C0C38CA}"/>
                  </a:ext>
                </a:extLst>
              </p:cNvPr>
              <p:cNvSpPr txBox="1"/>
              <p:nvPr/>
            </p:nvSpPr>
            <p:spPr>
              <a:xfrm rot="16200000">
                <a:off x="1907219" y="1142744"/>
                <a:ext cx="7329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g/mL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F9DBA776-FE93-82E9-44E3-50F3F4F39F74}"/>
                  </a:ext>
                </a:extLst>
              </p:cNvPr>
              <p:cNvSpPr txBox="1"/>
              <p:nvPr/>
            </p:nvSpPr>
            <p:spPr>
              <a:xfrm>
                <a:off x="2154212" y="656515"/>
                <a:ext cx="3267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F2FB4FF2-0108-735D-0E75-CDB329482023}"/>
                </a:ext>
              </a:extLst>
            </p:cNvPr>
            <p:cNvGrpSpPr/>
            <p:nvPr/>
          </p:nvGrpSpPr>
          <p:grpSpPr>
            <a:xfrm>
              <a:off x="992143" y="854087"/>
              <a:ext cx="2334964" cy="1599322"/>
              <a:chOff x="968287" y="873965"/>
              <a:chExt cx="2334964" cy="1599322"/>
            </a:xfrm>
          </p:grpSpPr>
          <p:graphicFrame>
            <p:nvGraphicFramePr>
              <p:cNvPr id="45" name="Object 44">
                <a:extLst>
                  <a:ext uri="{FF2B5EF4-FFF2-40B4-BE49-F238E27FC236}">
                    <a16:creationId xmlns:a16="http://schemas.microsoft.com/office/drawing/2014/main" id="{7A3BD7C5-0C4B-F183-84C0-09ACEFF2DC3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083704" y="873965"/>
              <a:ext cx="2219547" cy="159932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6" imgW="3613242" imgH="2603501" progId="Prism10.Document">
                      <p:embed/>
                    </p:oleObj>
                  </mc:Choice>
                  <mc:Fallback>
                    <p:oleObj name="Prism 10" r:id="rId6" imgW="3613242" imgH="2603501" progId="Prism10.Document">
                      <p:embed/>
                      <p:pic>
                        <p:nvPicPr>
                          <p:cNvPr id="45" name="Object 44">
                            <a:extLst>
                              <a:ext uri="{FF2B5EF4-FFF2-40B4-BE49-F238E27FC236}">
                                <a16:creationId xmlns:a16="http://schemas.microsoft.com/office/drawing/2014/main" id="{7A3BD7C5-0C4B-F183-84C0-09ACEFF2DC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1083704" y="873965"/>
                            <a:ext cx="2219547" cy="159932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9729A73C-B091-CD40-DB25-CD6B562D65A2}"/>
                  </a:ext>
                </a:extLst>
              </p:cNvPr>
              <p:cNvSpPr txBox="1"/>
              <p:nvPr/>
            </p:nvSpPr>
            <p:spPr>
              <a:xfrm>
                <a:off x="1063824" y="2123684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0</a:t>
                </a:r>
                <a:endParaRPr lang="en-US" sz="800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1DEB1DF-3EA2-18BF-6207-B82C7F0B6192}"/>
                  </a:ext>
                </a:extLst>
              </p:cNvPr>
              <p:cNvSpPr txBox="1"/>
              <p:nvPr/>
            </p:nvSpPr>
            <p:spPr>
              <a:xfrm>
                <a:off x="1017445" y="1850682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0.5</a:t>
                </a:r>
                <a:endParaRPr lang="en-US" sz="800" dirty="0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81917DBA-1F5A-B2CB-C2D6-923F4D4E4883}"/>
                  </a:ext>
                </a:extLst>
              </p:cNvPr>
              <p:cNvSpPr txBox="1"/>
              <p:nvPr/>
            </p:nvSpPr>
            <p:spPr>
              <a:xfrm>
                <a:off x="1020085" y="1565904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1.0</a:t>
                </a:r>
                <a:endParaRPr lang="en-US" sz="800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72A58BB-13AD-13B2-5F65-CB6F17449589}"/>
                  </a:ext>
                </a:extLst>
              </p:cNvPr>
              <p:cNvSpPr txBox="1"/>
              <p:nvPr/>
            </p:nvSpPr>
            <p:spPr>
              <a:xfrm>
                <a:off x="1020085" y="1284806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1.5</a:t>
                </a:r>
                <a:endParaRPr lang="en-US" sz="800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7F938B7-6F9B-154D-B41D-A0B2796A5963}"/>
                  </a:ext>
                </a:extLst>
              </p:cNvPr>
              <p:cNvSpPr txBox="1"/>
              <p:nvPr/>
            </p:nvSpPr>
            <p:spPr>
              <a:xfrm>
                <a:off x="1023321" y="1012997"/>
                <a:ext cx="408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2.0</a:t>
                </a:r>
                <a:endParaRPr lang="en-US" sz="800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3C3D8BF0-9647-EE44-41AC-19CE660844B2}"/>
                  </a:ext>
                </a:extLst>
              </p:cNvPr>
              <p:cNvSpPr txBox="1"/>
              <p:nvPr/>
            </p:nvSpPr>
            <p:spPr>
              <a:xfrm>
                <a:off x="1420089" y="1120719"/>
                <a:ext cx="8304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Ccl19</a:t>
                </a:r>
                <a:r>
                  <a:rPr lang="en-US" sz="800" i="1" baseline="300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Cre</a:t>
                </a:r>
                <a:endParaRPr lang="en-US" sz="800" dirty="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73EA21E-7704-4470-8004-8BC09F50E36A}"/>
                  </a:ext>
                </a:extLst>
              </p:cNvPr>
              <p:cNvSpPr txBox="1"/>
              <p:nvPr/>
            </p:nvSpPr>
            <p:spPr>
              <a:xfrm>
                <a:off x="1420090" y="1012997"/>
                <a:ext cx="720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Tlr9</a:t>
                </a:r>
                <a:r>
                  <a:rPr lang="en-US" sz="800" i="1" baseline="300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fl/</a:t>
                </a:r>
                <a:r>
                  <a:rPr lang="en-US" sz="800" i="1" baseline="30000" dirty="0" err="1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fl</a:t>
                </a:r>
                <a:endParaRPr lang="en-US" sz="800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F2A92B9-F33A-F663-7EDB-3988BF93F05E}"/>
                  </a:ext>
                </a:extLst>
              </p:cNvPr>
              <p:cNvSpPr txBox="1"/>
              <p:nvPr/>
            </p:nvSpPr>
            <p:spPr>
              <a:xfrm rot="16200000">
                <a:off x="491534" y="1515869"/>
                <a:ext cx="118433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5613D49-38D9-61DE-508C-E5250465A410}"/>
                  </a:ext>
                </a:extLst>
              </p:cNvPr>
              <p:cNvSpPr txBox="1"/>
              <p:nvPr/>
            </p:nvSpPr>
            <p:spPr>
              <a:xfrm>
                <a:off x="1173448" y="2222672"/>
                <a:ext cx="720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Tlr9</a:t>
                </a:r>
                <a:endParaRPr lang="en-US" sz="800" i="1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7A8EF32-E8C1-C57D-6D33-5362790E98D0}"/>
                  </a:ext>
                </a:extLst>
              </p:cNvPr>
              <p:cNvSpPr txBox="1"/>
              <p:nvPr/>
            </p:nvSpPr>
            <p:spPr>
              <a:xfrm>
                <a:off x="1584267" y="2223997"/>
                <a:ext cx="720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i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Ccl1</a:t>
                </a:r>
                <a:r>
                  <a:rPr lang="en-US" sz="800" i="1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</a:rPr>
                  <a:t>9</a:t>
                </a:r>
                <a:endParaRPr lang="en-US" sz="800" i="1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5C5C4C0-723C-AE3F-93D9-2CDCC5606EDB}"/>
                  </a:ext>
                </a:extLst>
              </p:cNvPr>
              <p:cNvSpPr txBox="1"/>
              <p:nvPr/>
            </p:nvSpPr>
            <p:spPr>
              <a:xfrm>
                <a:off x="2038648" y="2226146"/>
                <a:ext cx="720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i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Cxcl12</a:t>
                </a:r>
                <a:endParaRPr lang="en-US" sz="800" i="1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DFF54316-4608-152E-EB3B-39DED569A6EE}"/>
                  </a:ext>
                </a:extLst>
              </p:cNvPr>
              <p:cNvSpPr txBox="1"/>
              <p:nvPr/>
            </p:nvSpPr>
            <p:spPr>
              <a:xfrm>
                <a:off x="2478799" y="2226146"/>
                <a:ext cx="720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i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</a:rPr>
                  <a:t>Il6</a:t>
                </a:r>
                <a:endParaRPr lang="en-US" sz="800" i="1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17B280E5-9E1B-E601-6AAB-F3FEFC590B4D}"/>
                  </a:ext>
                </a:extLst>
              </p:cNvPr>
              <p:cNvSpPr txBox="1"/>
              <p:nvPr/>
            </p:nvSpPr>
            <p:spPr>
              <a:xfrm>
                <a:off x="983035" y="884334"/>
                <a:ext cx="3267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6CD417D-8386-B12D-C005-F174E7A4DD49}"/>
              </a:ext>
            </a:extLst>
          </p:cNvPr>
          <p:cNvSpPr txBox="1"/>
          <p:nvPr/>
        </p:nvSpPr>
        <p:spPr>
          <a:xfrm>
            <a:off x="803432" y="6636655"/>
            <a:ext cx="56608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A: Expression levels of Tlr9, Ccl19, Cxcl12, and Il6 in FRC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lr9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l/</a:t>
            </a:r>
            <a:r>
              <a:rPr lang="en-US" sz="1200" i="1" baseline="30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l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cl19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re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ice were assessed using qPCR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B &amp; C: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lr9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l/</a:t>
            </a:r>
            <a:r>
              <a:rPr lang="en-US" sz="1200" i="1" baseline="30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l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cl19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re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ice were subjected to CLP for 18 hours.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acterial load (B) and IL-6 levels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PLF and blood.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ymbols represent individual mice.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Data are shown as mean ± SD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9167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DF14BCFD-3E8E-100F-511A-EEB5D997DF85}"/>
              </a:ext>
            </a:extLst>
          </p:cNvPr>
          <p:cNvGrpSpPr/>
          <p:nvPr/>
        </p:nvGrpSpPr>
        <p:grpSpPr>
          <a:xfrm>
            <a:off x="371212" y="961835"/>
            <a:ext cx="3104868" cy="1334290"/>
            <a:chOff x="424469" y="995753"/>
            <a:chExt cx="3104868" cy="1334290"/>
          </a:xfrm>
        </p:grpSpPr>
        <p:pic>
          <p:nvPicPr>
            <p:cNvPr id="6" name="Picture 5" descr="A graph of a number of objects&#10;&#10;Description automatically generated with medium confidence">
              <a:extLst>
                <a:ext uri="{FF2B5EF4-FFF2-40B4-BE49-F238E27FC236}">
                  <a16:creationId xmlns:a16="http://schemas.microsoft.com/office/drawing/2014/main" id="{42613125-A36B-490C-5B83-323293F3DE4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5593" y="1079350"/>
              <a:ext cx="1368750" cy="1001841"/>
            </a:xfrm>
            <a:prstGeom prst="rect">
              <a:avLst/>
            </a:prstGeom>
          </p:spPr>
        </p:pic>
        <p:pic>
          <p:nvPicPr>
            <p:cNvPr id="8" name="Picture 7" descr="A map of the islands&#10;&#10;Description automatically generated with medium confidence">
              <a:extLst>
                <a:ext uri="{FF2B5EF4-FFF2-40B4-BE49-F238E27FC236}">
                  <a16:creationId xmlns:a16="http://schemas.microsoft.com/office/drawing/2014/main" id="{31632EB9-8D56-B264-2BEE-3BF284AB35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4079" y="1072596"/>
              <a:ext cx="1275258" cy="100250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8FAA6CC-AC00-C4DA-7A48-7864FDF37F22}"/>
                </a:ext>
              </a:extLst>
            </p:cNvPr>
            <p:cNvSpPr txBox="1"/>
            <p:nvPr/>
          </p:nvSpPr>
          <p:spPr>
            <a:xfrm>
              <a:off x="2368814" y="2009210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10006E2-108F-93C3-0A39-7A10C1B49712}"/>
                </a:ext>
              </a:extLst>
            </p:cNvPr>
            <p:cNvSpPr txBox="1"/>
            <p:nvPr/>
          </p:nvSpPr>
          <p:spPr>
            <a:xfrm>
              <a:off x="2723483" y="2014594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C897F4E-A08A-E0F5-D406-C45C1FA407A8}"/>
                </a:ext>
              </a:extLst>
            </p:cNvPr>
            <p:cNvSpPr txBox="1"/>
            <p:nvPr/>
          </p:nvSpPr>
          <p:spPr>
            <a:xfrm>
              <a:off x="2971043" y="2013895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AF61226-AAFA-53E1-5628-AA2667015EBD}"/>
                </a:ext>
              </a:extLst>
            </p:cNvPr>
            <p:cNvSpPr txBox="1"/>
            <p:nvPr/>
          </p:nvSpPr>
          <p:spPr>
            <a:xfrm>
              <a:off x="2557631" y="2114599"/>
              <a:ext cx="629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MAP_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20DA22F-A775-4066-6208-12B821353F6D}"/>
                </a:ext>
              </a:extLst>
            </p:cNvPr>
            <p:cNvSpPr txBox="1"/>
            <p:nvPr/>
          </p:nvSpPr>
          <p:spPr>
            <a:xfrm>
              <a:off x="2042719" y="996452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65D0D04-1D7C-12ED-DCF6-3E520D87DB92}"/>
                </a:ext>
              </a:extLst>
            </p:cNvPr>
            <p:cNvSpPr txBox="1"/>
            <p:nvPr/>
          </p:nvSpPr>
          <p:spPr>
            <a:xfrm>
              <a:off x="2095816" y="1231606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64258FB-CBB4-0107-3E7C-A38377E7EC45}"/>
                </a:ext>
              </a:extLst>
            </p:cNvPr>
            <p:cNvSpPr txBox="1"/>
            <p:nvPr/>
          </p:nvSpPr>
          <p:spPr>
            <a:xfrm>
              <a:off x="2099264" y="1454343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3F3C909-8A22-6C4F-36C6-CC2312A0699A}"/>
                </a:ext>
              </a:extLst>
            </p:cNvPr>
            <p:cNvSpPr txBox="1"/>
            <p:nvPr/>
          </p:nvSpPr>
          <p:spPr>
            <a:xfrm>
              <a:off x="2065617" y="1696247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82B3CDD-0DFC-1D7F-52E5-41D5269358CE}"/>
                </a:ext>
              </a:extLst>
            </p:cNvPr>
            <p:cNvSpPr txBox="1"/>
            <p:nvPr/>
          </p:nvSpPr>
          <p:spPr>
            <a:xfrm>
              <a:off x="2019409" y="1935537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3ECD267-95F5-6D75-425A-CE584A91FD32}"/>
                </a:ext>
              </a:extLst>
            </p:cNvPr>
            <p:cNvSpPr txBox="1"/>
            <p:nvPr/>
          </p:nvSpPr>
          <p:spPr>
            <a:xfrm rot="16200000">
              <a:off x="1786961" y="1393122"/>
              <a:ext cx="629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MAP_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529E38F-84F4-B91F-9B53-F79824FB6209}"/>
                </a:ext>
              </a:extLst>
            </p:cNvPr>
            <p:cNvSpPr txBox="1"/>
            <p:nvPr/>
          </p:nvSpPr>
          <p:spPr>
            <a:xfrm>
              <a:off x="2557631" y="995753"/>
              <a:ext cx="629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cl19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348EB78-537F-6E7B-CB37-D04EC885F9A2}"/>
                </a:ext>
              </a:extLst>
            </p:cNvPr>
            <p:cNvSpPr txBox="1"/>
            <p:nvPr/>
          </p:nvSpPr>
          <p:spPr>
            <a:xfrm>
              <a:off x="1233357" y="1008065"/>
              <a:ext cx="629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cl19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D02523E-BA11-E452-A51E-935EEFDAF005}"/>
                </a:ext>
              </a:extLst>
            </p:cNvPr>
            <p:cNvSpPr txBox="1"/>
            <p:nvPr/>
          </p:nvSpPr>
          <p:spPr>
            <a:xfrm>
              <a:off x="513134" y="1135423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5E41D7F-3640-455F-4008-07446F6547D5}"/>
                </a:ext>
              </a:extLst>
            </p:cNvPr>
            <p:cNvSpPr txBox="1"/>
            <p:nvPr/>
          </p:nvSpPr>
          <p:spPr>
            <a:xfrm>
              <a:off x="507055" y="1324235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335B6C3-827C-4A33-033A-A5A8B422DFFE}"/>
                </a:ext>
              </a:extLst>
            </p:cNvPr>
            <p:cNvSpPr txBox="1"/>
            <p:nvPr/>
          </p:nvSpPr>
          <p:spPr>
            <a:xfrm>
              <a:off x="511547" y="1704523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57D2443-397E-547D-1887-7C54167A992A}"/>
                </a:ext>
              </a:extLst>
            </p:cNvPr>
            <p:cNvSpPr txBox="1"/>
            <p:nvPr/>
          </p:nvSpPr>
          <p:spPr>
            <a:xfrm>
              <a:off x="512638" y="1897607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66BA615-F5E0-E8FC-460B-3571604322E1}"/>
                </a:ext>
              </a:extLst>
            </p:cNvPr>
            <p:cNvSpPr txBox="1"/>
            <p:nvPr/>
          </p:nvSpPr>
          <p:spPr>
            <a:xfrm rot="16200000">
              <a:off x="23271" y="1480548"/>
              <a:ext cx="10178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Level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00FD8B8-3010-CB53-AD8B-5A6A4630C2DE}"/>
                </a:ext>
              </a:extLst>
            </p:cNvPr>
            <p:cNvSpPr txBox="1"/>
            <p:nvPr/>
          </p:nvSpPr>
          <p:spPr>
            <a:xfrm>
              <a:off x="510456" y="1519819"/>
              <a:ext cx="349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161444C-4DCA-084D-21E1-E82EC8377AD7}"/>
                </a:ext>
              </a:extLst>
            </p:cNvPr>
            <p:cNvSpPr txBox="1"/>
            <p:nvPr/>
          </p:nvSpPr>
          <p:spPr>
            <a:xfrm>
              <a:off x="717229" y="2008521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C6D6206-FB1B-AB8B-A425-8D63D6297E49}"/>
                </a:ext>
              </a:extLst>
            </p:cNvPr>
            <p:cNvSpPr txBox="1"/>
            <p:nvPr/>
          </p:nvSpPr>
          <p:spPr>
            <a:xfrm>
              <a:off x="1193523" y="2100978"/>
              <a:ext cx="629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D1C9606-D418-673E-6798-839744BD913E}"/>
                </a:ext>
              </a:extLst>
            </p:cNvPr>
            <p:cNvSpPr txBox="1"/>
            <p:nvPr/>
          </p:nvSpPr>
          <p:spPr>
            <a:xfrm>
              <a:off x="840663" y="2011967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FA5933E-F441-6AB6-8588-41126E7CAEC9}"/>
                </a:ext>
              </a:extLst>
            </p:cNvPr>
            <p:cNvSpPr txBox="1"/>
            <p:nvPr/>
          </p:nvSpPr>
          <p:spPr>
            <a:xfrm>
              <a:off x="955821" y="2015408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81A6107-76CF-D62B-5325-04B912B1DD49}"/>
                </a:ext>
              </a:extLst>
            </p:cNvPr>
            <p:cNvSpPr txBox="1"/>
            <p:nvPr/>
          </p:nvSpPr>
          <p:spPr>
            <a:xfrm>
              <a:off x="1079601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FA996EE-7C81-8FBC-A4A0-8EB8BF6E652B}"/>
                </a:ext>
              </a:extLst>
            </p:cNvPr>
            <p:cNvSpPr txBox="1"/>
            <p:nvPr/>
          </p:nvSpPr>
          <p:spPr>
            <a:xfrm>
              <a:off x="1194336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DC686E3-63F1-A555-5461-AB73CA24933F}"/>
                </a:ext>
              </a:extLst>
            </p:cNvPr>
            <p:cNvSpPr txBox="1"/>
            <p:nvPr/>
          </p:nvSpPr>
          <p:spPr>
            <a:xfrm>
              <a:off x="1300840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F23FE89-4C93-EEEF-0433-348D4FD13ED7}"/>
                </a:ext>
              </a:extLst>
            </p:cNvPr>
            <p:cNvSpPr txBox="1"/>
            <p:nvPr/>
          </p:nvSpPr>
          <p:spPr>
            <a:xfrm>
              <a:off x="1429006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DC48BFA-A3D3-CBEF-6F45-1E402805507A}"/>
                </a:ext>
              </a:extLst>
            </p:cNvPr>
            <p:cNvSpPr txBox="1"/>
            <p:nvPr/>
          </p:nvSpPr>
          <p:spPr>
            <a:xfrm>
              <a:off x="1554823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F2D529A-9109-CADF-A2CA-78A658814CC7}"/>
                </a:ext>
              </a:extLst>
            </p:cNvPr>
            <p:cNvSpPr txBox="1"/>
            <p:nvPr/>
          </p:nvSpPr>
          <p:spPr>
            <a:xfrm>
              <a:off x="1673539" y="2013895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7041D2D-3345-9131-E98D-461F8546A4E0}"/>
                </a:ext>
              </a:extLst>
            </p:cNvPr>
            <p:cNvSpPr txBox="1"/>
            <p:nvPr/>
          </p:nvSpPr>
          <p:spPr>
            <a:xfrm>
              <a:off x="1793149" y="2013624"/>
              <a:ext cx="251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8809088-77DE-1088-7175-B8E7597AD47F}"/>
                </a:ext>
              </a:extLst>
            </p:cNvPr>
            <p:cNvSpPr txBox="1"/>
            <p:nvPr/>
          </p:nvSpPr>
          <p:spPr>
            <a:xfrm>
              <a:off x="1884398" y="2013624"/>
              <a:ext cx="3314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A3E003D3-67E7-0CAD-F644-3B9B2FAF5984}"/>
              </a:ext>
            </a:extLst>
          </p:cNvPr>
          <p:cNvSpPr txBox="1"/>
          <p:nvPr/>
        </p:nvSpPr>
        <p:spPr>
          <a:xfrm>
            <a:off x="447319" y="912488"/>
            <a:ext cx="326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47E9D14-5A1D-9D2E-921E-771FB7FAF7F2}"/>
              </a:ext>
            </a:extLst>
          </p:cNvPr>
          <p:cNvSpPr txBox="1"/>
          <p:nvPr/>
        </p:nvSpPr>
        <p:spPr>
          <a:xfrm>
            <a:off x="1923646" y="903143"/>
            <a:ext cx="326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833319-F86F-C5DF-62D5-3C2307B8C810}"/>
              </a:ext>
            </a:extLst>
          </p:cNvPr>
          <p:cNvSpPr txBox="1"/>
          <p:nvPr/>
        </p:nvSpPr>
        <p:spPr>
          <a:xfrm>
            <a:off x="282352" y="2584592"/>
            <a:ext cx="55127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 A: Violin plot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l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 B: Density plot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l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</a:t>
            </a:r>
          </a:p>
        </p:txBody>
      </p:sp>
    </p:spTree>
    <p:extLst>
      <p:ext uri="{BB962C8B-B14F-4D97-AF65-F5344CB8AC3E}">
        <p14:creationId xmlns:p14="http://schemas.microsoft.com/office/powerpoint/2010/main" val="2706946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a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1996ABA4-16DE-B193-FA10-BF5A99CAD7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9688" y="3886718"/>
            <a:ext cx="1299424" cy="1286942"/>
          </a:xfrm>
          <a:prstGeom prst="rect">
            <a:avLst/>
          </a:prstGeom>
        </p:spPr>
      </p:pic>
      <p:pic>
        <p:nvPicPr>
          <p:cNvPr id="7" name="Picture 6" descr="A grid of lines with numbers&#10;&#10;Description automatically generated">
            <a:extLst>
              <a:ext uri="{FF2B5EF4-FFF2-40B4-BE49-F238E27FC236}">
                <a16:creationId xmlns:a16="http://schemas.microsoft.com/office/drawing/2014/main" id="{563BBB62-A211-671F-79D7-7220F573B4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3116" y="3884222"/>
            <a:ext cx="1314403" cy="1291935"/>
          </a:xfrm>
          <a:prstGeom prst="rect">
            <a:avLst/>
          </a:prstGeom>
        </p:spPr>
      </p:pic>
      <p:pic>
        <p:nvPicPr>
          <p:cNvPr id="9" name="Picture 8" descr="A grid of lines with a contour of a person's face&#10;&#10;Description automatically generated">
            <a:extLst>
              <a:ext uri="{FF2B5EF4-FFF2-40B4-BE49-F238E27FC236}">
                <a16:creationId xmlns:a16="http://schemas.microsoft.com/office/drawing/2014/main" id="{2525A705-1966-4C30-0AA7-EFC14FC17C1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5081" y="3864250"/>
            <a:ext cx="1295680" cy="1306914"/>
          </a:xfrm>
          <a:prstGeom prst="rect">
            <a:avLst/>
          </a:prstGeom>
        </p:spPr>
      </p:pic>
      <p:pic>
        <p:nvPicPr>
          <p:cNvPr id="11" name="Picture 10" descr="A grid of lines with a grid of lines&#10;&#10;Description automatically generated with medium confidence">
            <a:extLst>
              <a:ext uri="{FF2B5EF4-FFF2-40B4-BE49-F238E27FC236}">
                <a16:creationId xmlns:a16="http://schemas.microsoft.com/office/drawing/2014/main" id="{F4C1CFA4-C758-ED60-441B-4799C29C441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874" y="3859257"/>
            <a:ext cx="1295680" cy="1316900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ABF6A6F-F9BD-4DDE-F24B-7B2A3E8230F9}"/>
              </a:ext>
            </a:extLst>
          </p:cNvPr>
          <p:cNvCxnSpPr/>
          <p:nvPr/>
        </p:nvCxnSpPr>
        <p:spPr>
          <a:xfrm flipV="1">
            <a:off x="669468" y="3971925"/>
            <a:ext cx="0" cy="10572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9CE1068-9D3F-C143-CC34-E172999DA1C1}"/>
              </a:ext>
            </a:extLst>
          </p:cNvPr>
          <p:cNvCxnSpPr>
            <a:cxnSpLocks/>
          </p:cNvCxnSpPr>
          <p:nvPr/>
        </p:nvCxnSpPr>
        <p:spPr>
          <a:xfrm>
            <a:off x="870854" y="5250997"/>
            <a:ext cx="499926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FA54D612-089E-8E97-FB00-0F08F52680B1}"/>
              </a:ext>
            </a:extLst>
          </p:cNvPr>
          <p:cNvSpPr txBox="1"/>
          <p:nvPr/>
        </p:nvSpPr>
        <p:spPr>
          <a:xfrm rot="16200000">
            <a:off x="230653" y="4231387"/>
            <a:ext cx="749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5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26B0528-717D-D920-8774-FF9143B19846}"/>
              </a:ext>
            </a:extLst>
          </p:cNvPr>
          <p:cNvSpPr txBox="1"/>
          <p:nvPr/>
        </p:nvSpPr>
        <p:spPr>
          <a:xfrm>
            <a:off x="2086103" y="5210422"/>
            <a:ext cx="749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6A76EB7-14C2-0AD8-1E2B-FCB447E093D9}"/>
              </a:ext>
            </a:extLst>
          </p:cNvPr>
          <p:cNvSpPr txBox="1"/>
          <p:nvPr/>
        </p:nvSpPr>
        <p:spPr>
          <a:xfrm>
            <a:off x="1144489" y="3703925"/>
            <a:ext cx="749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2457B9F-237A-44FE-3720-8BCA1F870EAE}"/>
              </a:ext>
            </a:extLst>
          </p:cNvPr>
          <p:cNvSpPr txBox="1"/>
          <p:nvPr/>
        </p:nvSpPr>
        <p:spPr>
          <a:xfrm>
            <a:off x="2440169" y="3703925"/>
            <a:ext cx="749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D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165BCA-3629-9696-16D1-C4AD9BFD68DB}"/>
              </a:ext>
            </a:extLst>
          </p:cNvPr>
          <p:cNvSpPr txBox="1"/>
          <p:nvPr/>
        </p:nvSpPr>
        <p:spPr>
          <a:xfrm>
            <a:off x="3807353" y="3703925"/>
            <a:ext cx="749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90A5E7-3493-ED05-73BE-32A5E5CF5287}"/>
              </a:ext>
            </a:extLst>
          </p:cNvPr>
          <p:cNvSpPr txBox="1"/>
          <p:nvPr/>
        </p:nvSpPr>
        <p:spPr>
          <a:xfrm>
            <a:off x="4986786" y="3705346"/>
            <a:ext cx="8824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DN+ LP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2DCDB24-564D-D2FF-ADC8-DD44B8CF90C7}"/>
              </a:ext>
            </a:extLst>
          </p:cNvPr>
          <p:cNvSpPr txBox="1"/>
          <p:nvPr/>
        </p:nvSpPr>
        <p:spPr>
          <a:xfrm>
            <a:off x="132723" y="5325838"/>
            <a:ext cx="55127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Representative gating for IL-6 expression in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FRC subset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5928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265</TotalTime>
  <Words>294</Words>
  <Application>Microsoft Office PowerPoint</Application>
  <PresentationFormat>A4 Paper (210x297 mm)</PresentationFormat>
  <Paragraphs>9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g, Meihong</dc:creator>
  <cp:lastModifiedBy>Deng, Meihong</cp:lastModifiedBy>
  <cp:revision>5</cp:revision>
  <dcterms:created xsi:type="dcterms:W3CDTF">2023-09-28T17:54:13Z</dcterms:created>
  <dcterms:modified xsi:type="dcterms:W3CDTF">2024-03-06T14:05:40Z</dcterms:modified>
</cp:coreProperties>
</file>